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58947551-4A14-424E-A6C5-60CB49EC3EB0}"/>
              </a:ext>
            </a:extLst>
          </p:cNvPr>
          <p:cNvSpPr/>
          <p:nvPr/>
        </p:nvSpPr>
        <p:spPr>
          <a:xfrm>
            <a:off x="1242390" y="424113"/>
            <a:ext cx="993913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1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Funnel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plot for Ng levels in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AD vs. HC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ircles indicate individual studies. The solid line indicates the combined SMD and the dotted line indicates the 95% CI. AD, Alzheimer’s disease. HC, healthy controls. SMD, standard mean difference. CI, confidence interval. se, standard error.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1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B93BB32A-A347-430B-9682-834D62E11A2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3862" y="1446445"/>
            <a:ext cx="6744276" cy="4984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2019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4</TotalTime>
  <Words>63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8</cp:revision>
  <dcterms:created xsi:type="dcterms:W3CDTF">2019-09-16T04:07:01Z</dcterms:created>
  <dcterms:modified xsi:type="dcterms:W3CDTF">2020-03-12T01:15:48Z</dcterms:modified>
</cp:coreProperties>
</file>